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A94364-3F11-49B2-8160-8899DC7A337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5CA214-7B72-4B2C-B3EF-B8C7AB845A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087EE7-A566-486A-A396-C8BE912349B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AC37AD-741A-4D08-9460-3F8CA754C90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5B3B5A-E5B0-446D-9B02-A3987E3079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5E4464-FB77-428B-94AA-C1FB9DAE06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40A2AD-77D2-496B-98CA-C78E2E4621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41A506-5297-4D07-9EB3-48088EADB4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BAF7E4-C5A0-4916-B122-83DC17E691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45A489-9899-45AC-AA12-402E84E3E1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E66DB0-E7EA-4ED8-B629-F34BD06B22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CA43BE-4796-4FF7-8C2B-36370D08EA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FDBA35E-7460-447F-ADC5-43BD1D09F10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1371600" y="434880"/>
            <a:ext cx="5977080" cy="4240800"/>
            <a:chOff x="1371600" y="434880"/>
            <a:chExt cx="5977080" cy="4240800"/>
          </a:xfrm>
        </p:grpSpPr>
        <p:pic>
          <p:nvPicPr>
            <p:cNvPr id="42" name="Picture 2" descr=""/>
            <p:cNvPicPr/>
            <p:nvPr/>
          </p:nvPicPr>
          <p:blipFill>
            <a:blip r:embed="rId1"/>
            <a:srcRect l="14071" t="9475" r="3844" b="13144"/>
            <a:stretch/>
          </p:blipFill>
          <p:spPr>
            <a:xfrm>
              <a:off x="1749600" y="758160"/>
              <a:ext cx="2382480" cy="148356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43" name="Picture 2" descr="F:\Fv_Mummer\promer_S_imp\Figures\Foxy_fvN50_promer_l100.jpg"/>
            <p:cNvPicPr/>
            <p:nvPr/>
          </p:nvPicPr>
          <p:blipFill>
            <a:blip r:embed="rId2"/>
            <a:srcRect l="14395" t="10059" r="3960" b="12854"/>
            <a:stretch/>
          </p:blipFill>
          <p:spPr>
            <a:xfrm>
              <a:off x="4549320" y="758160"/>
              <a:ext cx="2421000" cy="150984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44" name="Picture 2" descr="F:\Fv_Mummer\promer_S_imp\Figures\Fverti_fvN50_promer_l100.jpg"/>
            <p:cNvPicPr/>
            <p:nvPr/>
          </p:nvPicPr>
          <p:blipFill>
            <a:blip r:embed="rId3"/>
            <a:srcRect l="14291" t="10082" r="5197" b="12608"/>
            <a:stretch/>
          </p:blipFill>
          <p:spPr>
            <a:xfrm>
              <a:off x="1749600" y="2763000"/>
              <a:ext cx="2345400" cy="14875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45" name="Picture 2" descr="F:\Fv_Mummer\promer_S_imp\Figures\Nect_fvN50_promer_l100-1.jpg"/>
            <p:cNvPicPr/>
            <p:nvPr/>
          </p:nvPicPr>
          <p:blipFill>
            <a:blip r:embed="rId4"/>
            <a:srcRect l="14408" t="10177" r="4397" b="13557"/>
            <a:stretch/>
          </p:blipFill>
          <p:spPr>
            <a:xfrm>
              <a:off x="4549320" y="2722680"/>
              <a:ext cx="2421000" cy="15019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sp>
          <p:nvSpPr>
            <p:cNvPr id="46" name="TextBox 6"/>
            <p:cNvSpPr/>
            <p:nvPr/>
          </p:nvSpPr>
          <p:spPr>
            <a:xfrm>
              <a:off x="1531080" y="850320"/>
              <a:ext cx="196560" cy="1797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10"/>
            <p:cNvSpPr/>
            <p:nvPr/>
          </p:nvSpPr>
          <p:spPr>
            <a:xfrm>
              <a:off x="1573920" y="2801520"/>
              <a:ext cx="196560" cy="1310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11"/>
            <p:cNvSpPr/>
            <p:nvPr/>
          </p:nvSpPr>
          <p:spPr>
            <a:xfrm>
              <a:off x="4381560" y="817200"/>
              <a:ext cx="196560" cy="1310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12"/>
            <p:cNvSpPr/>
            <p:nvPr/>
          </p:nvSpPr>
          <p:spPr>
            <a:xfrm>
              <a:off x="4381560" y="2797920"/>
              <a:ext cx="196560" cy="1310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14"/>
            <p:cNvSpPr/>
            <p:nvPr/>
          </p:nvSpPr>
          <p:spPr>
            <a:xfrm>
              <a:off x="1749600" y="2204640"/>
              <a:ext cx="2489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        2       3       4        5       6       7        8      9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15"/>
            <p:cNvSpPr/>
            <p:nvPr/>
          </p:nvSpPr>
          <p:spPr>
            <a:xfrm rot="16200000">
              <a:off x="609480" y="3327840"/>
              <a:ext cx="186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F. virguliform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6"/>
            <p:cNvSpPr/>
            <p:nvPr/>
          </p:nvSpPr>
          <p:spPr>
            <a:xfrm rot="16200000">
              <a:off x="581760" y="1224720"/>
              <a:ext cx="1810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F. virguliform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19"/>
            <p:cNvSpPr/>
            <p:nvPr/>
          </p:nvSpPr>
          <p:spPr>
            <a:xfrm>
              <a:off x="2031120" y="2373120"/>
              <a:ext cx="2269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F. graminearum 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20"/>
            <p:cNvSpPr/>
            <p:nvPr/>
          </p:nvSpPr>
          <p:spPr>
            <a:xfrm>
              <a:off x="4700520" y="2373120"/>
              <a:ext cx="2269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F. verticillioide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22"/>
            <p:cNvSpPr/>
            <p:nvPr/>
          </p:nvSpPr>
          <p:spPr>
            <a:xfrm>
              <a:off x="1371600" y="434880"/>
              <a:ext cx="378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23"/>
            <p:cNvSpPr/>
            <p:nvPr/>
          </p:nvSpPr>
          <p:spPr>
            <a:xfrm>
              <a:off x="4549320" y="434880"/>
              <a:ext cx="378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24"/>
            <p:cNvSpPr/>
            <p:nvPr/>
          </p:nvSpPr>
          <p:spPr>
            <a:xfrm>
              <a:off x="1371600" y="2504160"/>
              <a:ext cx="378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25"/>
            <p:cNvSpPr/>
            <p:nvPr/>
          </p:nvSpPr>
          <p:spPr>
            <a:xfrm>
              <a:off x="4549320" y="2508840"/>
              <a:ext cx="378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D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26"/>
            <p:cNvSpPr/>
            <p:nvPr/>
          </p:nvSpPr>
          <p:spPr>
            <a:xfrm>
              <a:off x="1764720" y="4436640"/>
              <a:ext cx="2269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F. oxysporum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(Mb DNA) 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27"/>
            <p:cNvSpPr/>
            <p:nvPr/>
          </p:nvSpPr>
          <p:spPr>
            <a:xfrm>
              <a:off x="4664520" y="4444560"/>
              <a:ext cx="2684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N. haematococca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29"/>
            <p:cNvSpPr/>
            <p:nvPr/>
          </p:nvSpPr>
          <p:spPr>
            <a:xfrm>
              <a:off x="4379400" y="2251800"/>
              <a:ext cx="266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5     1       1.5      2       2.5      3      3.5     4     4.5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31"/>
            <p:cNvSpPr/>
            <p:nvPr/>
          </p:nvSpPr>
          <p:spPr>
            <a:xfrm>
              <a:off x="1543680" y="4250520"/>
              <a:ext cx="2705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5     1      1.5      2      2.5      3     3.5      4      4.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33"/>
            <p:cNvSpPr/>
            <p:nvPr/>
          </p:nvSpPr>
          <p:spPr>
            <a:xfrm>
              <a:off x="4379400" y="4250520"/>
              <a:ext cx="2705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5   1     1.5     2     2.5     3      3.5     4     4.5    5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34"/>
            <p:cNvSpPr/>
            <p:nvPr/>
          </p:nvSpPr>
          <p:spPr>
            <a:xfrm rot="16200000">
              <a:off x="3453840" y="3304440"/>
              <a:ext cx="1810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F. virguliform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35"/>
            <p:cNvSpPr/>
            <p:nvPr/>
          </p:nvSpPr>
          <p:spPr>
            <a:xfrm rot="16200000">
              <a:off x="3453840" y="1384560"/>
              <a:ext cx="1810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F. virguliform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6" name="TextBox 21"/>
          <p:cNvSpPr/>
          <p:nvPr/>
        </p:nvSpPr>
        <p:spPr>
          <a:xfrm>
            <a:off x="1550880" y="4925880"/>
            <a:ext cx="622152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spcBef>
                <a:spcPts val="2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1. Dot-plot analyses of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. virguliforme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with four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usarium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spp.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The alignments are between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usarium virguliforme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caffold 1 (5.05 Mb) and genome sequences of the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usarium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spp.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A)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. virguliforme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with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. graminearum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(8.93 Mb); B)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. virguliforme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with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. verticilliodes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(4.62 Mb); C)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. virguliforme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with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. oxysporum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(4.35 Mb); D)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. virguliforme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with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N. haematococca (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4.93 Mb)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08T00:16:43Z</dcterms:created>
  <dc:creator>Subodh</dc:creator>
  <dc:description/>
  <dc:language>en-US</dc:language>
  <cp:lastModifiedBy>Bhattacharyya, Madan K [AGRON]</cp:lastModifiedBy>
  <dcterms:modified xsi:type="dcterms:W3CDTF">2013-06-18T21:19:12Z</dcterms:modified>
  <cp:revision>16</cp:revision>
  <dc:subject/>
  <dc:title>PowerPoint Presentation</dc:title>
</cp:coreProperties>
</file>